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4" r:id="rId2"/>
  </p:sldIdLst>
  <p:sldSz cx="6858000" cy="9144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보통 스타일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613" autoAdjust="0"/>
    <p:restoredTop sz="91504" autoAdjust="0"/>
  </p:normalViewPr>
  <p:slideViewPr>
    <p:cSldViewPr>
      <p:cViewPr>
        <p:scale>
          <a:sx n="75" d="100"/>
          <a:sy n="75" d="100"/>
        </p:scale>
        <p:origin x="-288" y="90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5671E3-521F-4D06-BC2E-51F5FA4EA279}" type="datetimeFigureOut">
              <a:rPr lang="ko-KR" altLang="en-US" smtClean="0"/>
              <a:pPr/>
              <a:t>2014-06-0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203A0F-198F-4D20-9567-02B97527555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050749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B038A4-2E74-4B29-8499-C9FE38D72DBA}" type="datetimeFigureOut">
              <a:rPr lang="ko-KR" altLang="en-US" smtClean="0"/>
              <a:pPr/>
              <a:t>2014-06-0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EBC9CA-CF10-4168-B1F4-9312155EC5E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09410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altLang="ko-KR" dirty="0" smtClean="0"/>
              <a:t>Figure</a:t>
            </a:r>
            <a:r>
              <a:rPr lang="ko-KR" altLang="en-US" dirty="0" smtClean="0"/>
              <a:t> </a:t>
            </a:r>
            <a:r>
              <a:rPr lang="en-US" altLang="ko-KR" dirty="0" smtClean="0"/>
              <a:t>legend </a:t>
            </a:r>
            <a:r>
              <a:rPr lang="ko-KR" altLang="en-US" dirty="0" smtClean="0"/>
              <a:t>는</a:t>
            </a:r>
            <a:r>
              <a:rPr lang="en-US" altLang="ko-KR" dirty="0" smtClean="0"/>
              <a:t> </a:t>
            </a:r>
            <a:r>
              <a:rPr lang="ko-KR" altLang="en-US" dirty="0" smtClean="0"/>
              <a:t>본문에 옮겨놓았습니다</a:t>
            </a:r>
            <a:r>
              <a:rPr lang="en-US" altLang="ko-KR" dirty="0" smtClean="0"/>
              <a:t>.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DEBC9CA-CF10-4168-B1F4-9312155EC5E9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2A93D-266B-4818-A872-04D7BC2DA202}" type="datetimeFigureOut">
              <a:rPr lang="ko-KR" altLang="en-US" smtClean="0"/>
              <a:pPr/>
              <a:t>2014-06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3248-78E5-494E-8CDD-1EE91EDE02E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78908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2A93D-266B-4818-A872-04D7BC2DA202}" type="datetimeFigureOut">
              <a:rPr lang="ko-KR" altLang="en-US" smtClean="0"/>
              <a:pPr/>
              <a:t>2014-06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3248-78E5-494E-8CDD-1EE91EDE02E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2917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2A93D-266B-4818-A872-04D7BC2DA202}" type="datetimeFigureOut">
              <a:rPr lang="ko-KR" altLang="en-US" smtClean="0"/>
              <a:pPr/>
              <a:t>2014-06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3248-78E5-494E-8CDD-1EE91EDE02E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8016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2A93D-266B-4818-A872-04D7BC2DA202}" type="datetimeFigureOut">
              <a:rPr lang="ko-KR" altLang="en-US" smtClean="0"/>
              <a:pPr/>
              <a:t>2014-06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3248-78E5-494E-8CDD-1EE91EDE02E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40222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2A93D-266B-4818-A872-04D7BC2DA202}" type="datetimeFigureOut">
              <a:rPr lang="ko-KR" altLang="en-US" smtClean="0"/>
              <a:pPr/>
              <a:t>2014-06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3248-78E5-494E-8CDD-1EE91EDE02E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925972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2A93D-266B-4818-A872-04D7BC2DA202}" type="datetimeFigureOut">
              <a:rPr lang="ko-KR" altLang="en-US" smtClean="0"/>
              <a:pPr/>
              <a:t>2014-06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3248-78E5-494E-8CDD-1EE91EDE02E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0829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2A93D-266B-4818-A872-04D7BC2DA202}" type="datetimeFigureOut">
              <a:rPr lang="ko-KR" altLang="en-US" smtClean="0"/>
              <a:pPr/>
              <a:t>2014-06-0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3248-78E5-494E-8CDD-1EE91EDE02E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24713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2A93D-266B-4818-A872-04D7BC2DA202}" type="datetimeFigureOut">
              <a:rPr lang="ko-KR" altLang="en-US" smtClean="0"/>
              <a:pPr/>
              <a:t>2014-06-0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3248-78E5-494E-8CDD-1EE91EDE02E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6014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2A93D-266B-4818-A872-04D7BC2DA202}" type="datetimeFigureOut">
              <a:rPr lang="ko-KR" altLang="en-US" smtClean="0"/>
              <a:pPr/>
              <a:t>2014-06-0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3248-78E5-494E-8CDD-1EE91EDE02E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693627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2A93D-266B-4818-A872-04D7BC2DA202}" type="datetimeFigureOut">
              <a:rPr lang="ko-KR" altLang="en-US" smtClean="0"/>
              <a:pPr/>
              <a:t>2014-06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3248-78E5-494E-8CDD-1EE91EDE02E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23149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62A93D-266B-4818-A872-04D7BC2DA202}" type="datetimeFigureOut">
              <a:rPr lang="ko-KR" altLang="en-US" smtClean="0"/>
              <a:pPr/>
              <a:t>2014-06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E23248-78E5-494E-8CDD-1EE91EDE02E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58847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62A93D-266B-4818-A872-04D7BC2DA202}" type="datetimeFigureOut">
              <a:rPr lang="ko-KR" altLang="en-US" smtClean="0"/>
              <a:pPr/>
              <a:t>2014-06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E23248-78E5-494E-8CDD-1EE91EDE02E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602993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아래쪽 화살표 20"/>
          <p:cNvSpPr/>
          <p:nvPr/>
        </p:nvSpPr>
        <p:spPr>
          <a:xfrm>
            <a:off x="4214818" y="1571604"/>
            <a:ext cx="214443" cy="576064"/>
          </a:xfrm>
          <a:prstGeom prst="downArrow">
            <a:avLst/>
          </a:prstGeom>
          <a:solidFill>
            <a:srgbClr val="0FFD3C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b="1"/>
          </a:p>
        </p:txBody>
      </p:sp>
      <p:sp>
        <p:nvSpPr>
          <p:cNvPr id="22" name="아래쪽 화살표 21"/>
          <p:cNvSpPr/>
          <p:nvPr/>
        </p:nvSpPr>
        <p:spPr>
          <a:xfrm flipV="1">
            <a:off x="4214818" y="2786050"/>
            <a:ext cx="204212" cy="680627"/>
          </a:xfrm>
          <a:prstGeom prst="downArrow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b="1"/>
          </a:p>
        </p:txBody>
      </p:sp>
      <p:graphicFrame>
        <p:nvGraphicFramePr>
          <p:cNvPr id="105" name="표 104"/>
          <p:cNvGraphicFramePr>
            <a:graphicFrameLocks noGrp="1"/>
          </p:cNvGraphicFramePr>
          <p:nvPr/>
        </p:nvGraphicFramePr>
        <p:xfrm>
          <a:off x="2571744" y="1000100"/>
          <a:ext cx="1524000" cy="2743200"/>
        </p:xfrm>
        <a:graphic>
          <a:graphicData uri="http://schemas.openxmlformats.org/drawingml/2006/table">
            <a:tbl>
              <a:tblPr/>
              <a:tblGrid>
                <a:gridCol w="762000"/>
                <a:gridCol w="762000"/>
              </a:tblGrid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 dirty="0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00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33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3300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3300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33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00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00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0000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0000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0000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0000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0000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0000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 dirty="0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06" name="표 105"/>
          <p:cNvGraphicFramePr>
            <a:graphicFrameLocks noGrp="1"/>
          </p:cNvGraphicFramePr>
          <p:nvPr/>
        </p:nvGraphicFramePr>
        <p:xfrm>
          <a:off x="1785926" y="1000100"/>
          <a:ext cx="762000" cy="2743200"/>
        </p:xfrm>
        <a:graphic>
          <a:graphicData uri="http://schemas.openxmlformats.org/drawingml/2006/table">
            <a:tbl>
              <a:tblPr/>
              <a:tblGrid>
                <a:gridCol w="762000"/>
              </a:tblGrid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d24a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dh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tnna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tnnb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ldn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ldn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Ocl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Elf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Dsg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Fn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Vim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Snai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Foxc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as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la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Dc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107" name="TextBox 106"/>
          <p:cNvSpPr txBox="1"/>
          <p:nvPr/>
        </p:nvSpPr>
        <p:spPr>
          <a:xfrm>
            <a:off x="2571744" y="785786"/>
            <a:ext cx="8178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TUBO-P2J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3453350" y="785786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4T1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09" name="표 108"/>
          <p:cNvGraphicFramePr>
            <a:graphicFrameLocks noGrp="1"/>
          </p:cNvGraphicFramePr>
          <p:nvPr/>
        </p:nvGraphicFramePr>
        <p:xfrm>
          <a:off x="4786322" y="1000100"/>
          <a:ext cx="309562" cy="1543050"/>
        </p:xfrm>
        <a:graphic>
          <a:graphicData uri="http://schemas.openxmlformats.org/drawingml/2006/table">
            <a:tbl>
              <a:tblPr/>
              <a:tblGrid>
                <a:gridCol w="309562"/>
              </a:tblGrid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0000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600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900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CC00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8000"/>
                    </a:solidFil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900" b="0" i="0" u="none" strike="noStrike" dirty="0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3300"/>
                    </a:solidFill>
                  </a:tcPr>
                </a:tc>
              </a:tr>
            </a:tbl>
          </a:graphicData>
        </a:graphic>
      </p:graphicFrame>
      <p:sp>
        <p:nvSpPr>
          <p:cNvPr id="110" name="TextBox 109"/>
          <p:cNvSpPr txBox="1"/>
          <p:nvPr/>
        </p:nvSpPr>
        <p:spPr>
          <a:xfrm>
            <a:off x="5143512" y="164304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1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5143512" y="2325515"/>
            <a:ext cx="4363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&lt;0.1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5143512" y="968193"/>
            <a:ext cx="4010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&gt;10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4714884" y="642910"/>
            <a:ext cx="9236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Color</a:t>
            </a:r>
            <a:r>
              <a:rPr lang="ko-KR" altLang="en-US" sz="1000" b="1" dirty="0" smtClean="0">
                <a:latin typeface="Arial" pitchFamily="34" charset="0"/>
                <a:cs typeface="Arial" pitchFamily="34" charset="0"/>
              </a:rPr>
              <a:t>  </a:t>
            </a:r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index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5134825" y="785786"/>
            <a:ext cx="4555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Fold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18" name="표 117"/>
          <p:cNvGraphicFramePr>
            <a:graphicFrameLocks noGrp="1"/>
          </p:cNvGraphicFramePr>
          <p:nvPr/>
        </p:nvGraphicFramePr>
        <p:xfrm>
          <a:off x="1857363" y="4000497"/>
          <a:ext cx="2786082" cy="3429019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928694"/>
                <a:gridCol w="928694"/>
                <a:gridCol w="928694"/>
              </a:tblGrid>
              <a:tr h="201707"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TUBO-P2J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T1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170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d24a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.801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.587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170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dh1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.011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.036 </a:t>
                      </a:r>
                      <a:endParaRPr lang="en-US" altLang="ko-KR" sz="1200" b="1" i="0" u="none" strike="noStrike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170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tnna1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.016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.714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170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tnnb1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.710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.743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170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ldn1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.017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.089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170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ldn3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.070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.380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170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Ocln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.106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.586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170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Elf3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.368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.526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170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Dsg3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.232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0.299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170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Fn1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50.016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25.620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170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Vim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2.228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3.011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170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nai1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19.753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7.981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170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Foxc2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73.228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9.510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170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Has2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9.926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13.394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170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Plat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3.397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1.655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170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 err="1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Dcn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74.951 </a:t>
                      </a:r>
                      <a:endParaRPr lang="en-US" altLang="ko-KR" sz="1200" b="1" i="0" u="none" strike="noStrike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6.993 </a:t>
                      </a:r>
                      <a:endParaRPr lang="en-US" altLang="ko-KR" sz="12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16" name="직사각형 15"/>
          <p:cNvSpPr/>
          <p:nvPr/>
        </p:nvSpPr>
        <p:spPr>
          <a:xfrm>
            <a:off x="2357430" y="8501090"/>
            <a:ext cx="171072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fontAlgn="base" latinLnBrk="0">
              <a:spcBef>
                <a:spcPct val="0"/>
              </a:spcBef>
              <a:spcAft>
                <a:spcPct val="0"/>
              </a:spcAft>
            </a:pPr>
            <a:r>
              <a:rPr lang="en-US" altLang="zh-CN" sz="12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ong </a:t>
            </a:r>
            <a:r>
              <a:rPr lang="en-US" altLang="zh-CN" sz="1200" b="1" i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et al</a:t>
            </a:r>
            <a:r>
              <a:rPr lang="en-US" altLang="zh-CN" sz="12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. Figure </a:t>
            </a:r>
            <a:r>
              <a:rPr lang="en-US" altLang="zh-CN" sz="12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3</a:t>
            </a:r>
            <a:endParaRPr lang="en-US" altLang="ko-KR" sz="1200" b="1" dirty="0">
              <a:solidFill>
                <a:prstClr val="black"/>
              </a:solidFill>
              <a:latin typeface="Arial" pitchFamily="34" charset="0"/>
              <a:ea typeface="宋体" pitchFamily="2" charset="-122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85666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383</TotalTime>
  <Words>89</Words>
  <Application>Microsoft Office PowerPoint</Application>
  <PresentationFormat>화면 슬라이드 쇼(4:3)</PresentationFormat>
  <Paragraphs>117</Paragraphs>
  <Slides>1</Slides>
  <Notes>1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aeGwang Park</dc:creator>
  <cp:lastModifiedBy>SaeGwang Park</cp:lastModifiedBy>
  <cp:revision>139</cp:revision>
  <cp:lastPrinted>2013-10-14T06:03:47Z</cp:lastPrinted>
  <dcterms:created xsi:type="dcterms:W3CDTF">2013-03-28T09:39:40Z</dcterms:created>
  <dcterms:modified xsi:type="dcterms:W3CDTF">2014-06-04T01:35:22Z</dcterms:modified>
</cp:coreProperties>
</file>